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60" r:id="rId3"/>
    <p:sldId id="261" r:id="rId4"/>
    <p:sldId id="262" r:id="rId5"/>
    <p:sldId id="263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3354"/>
    <p:restoredTop sz="94694"/>
  </p:normalViewPr>
  <p:slideViewPr>
    <p:cSldViewPr snapToGrid="0" snapToObjects="1">
      <p:cViewPr>
        <p:scale>
          <a:sx n="150" d="100"/>
          <a:sy n="150" d="100"/>
        </p:scale>
        <p:origin x="-534" y="38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678BB2-6DC9-2742-9347-42D27A5897B3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04A0D1-F08F-E54B-8B4C-2B32B5688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2822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5413D-BED4-8B43-998B-D1029AF82A2F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C079B-F81B-974C-8269-5B097668F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63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5413D-BED4-8B43-998B-D1029AF82A2F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C079B-F81B-974C-8269-5B097668F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415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5413D-BED4-8B43-998B-D1029AF82A2F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C079B-F81B-974C-8269-5B097668F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792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5413D-BED4-8B43-998B-D1029AF82A2F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C079B-F81B-974C-8269-5B097668F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1269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5413D-BED4-8B43-998B-D1029AF82A2F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C079B-F81B-974C-8269-5B097668F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996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5413D-BED4-8B43-998B-D1029AF82A2F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C079B-F81B-974C-8269-5B097668F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04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5413D-BED4-8B43-998B-D1029AF82A2F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C079B-F81B-974C-8269-5B097668F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972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5413D-BED4-8B43-998B-D1029AF82A2F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C079B-F81B-974C-8269-5B097668F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800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5413D-BED4-8B43-998B-D1029AF82A2F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C079B-F81B-974C-8269-5B097668F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078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5413D-BED4-8B43-998B-D1029AF82A2F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C079B-F81B-974C-8269-5B097668F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197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5413D-BED4-8B43-998B-D1029AF82A2F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AC079B-F81B-974C-8269-5B097668F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335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F5413D-BED4-8B43-998B-D1029AF82A2F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AC079B-F81B-974C-8269-5B097668F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601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3" Type="http://schemas.openxmlformats.org/officeDocument/2006/relationships/image" Target="../media/image13.emf"/><Relationship Id="rId7" Type="http://schemas.openxmlformats.org/officeDocument/2006/relationships/image" Target="../media/image17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11" Type="http://schemas.openxmlformats.org/officeDocument/2006/relationships/image" Target="../media/image21.emf"/><Relationship Id="rId5" Type="http://schemas.openxmlformats.org/officeDocument/2006/relationships/image" Target="../media/image15.emf"/><Relationship Id="rId10" Type="http://schemas.openxmlformats.org/officeDocument/2006/relationships/image" Target="../media/image20.emf"/><Relationship Id="rId4" Type="http://schemas.openxmlformats.org/officeDocument/2006/relationships/image" Target="../media/image14.emf"/><Relationship Id="rId9" Type="http://schemas.openxmlformats.org/officeDocument/2006/relationships/image" Target="../media/image19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13" Type="http://schemas.openxmlformats.org/officeDocument/2006/relationships/image" Target="../media/image33.emf"/><Relationship Id="rId3" Type="http://schemas.openxmlformats.org/officeDocument/2006/relationships/image" Target="../media/image23.emf"/><Relationship Id="rId7" Type="http://schemas.openxmlformats.org/officeDocument/2006/relationships/image" Target="../media/image27.emf"/><Relationship Id="rId12" Type="http://schemas.openxmlformats.org/officeDocument/2006/relationships/image" Target="../media/image32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emf"/><Relationship Id="rId11" Type="http://schemas.openxmlformats.org/officeDocument/2006/relationships/image" Target="../media/image31.emf"/><Relationship Id="rId5" Type="http://schemas.openxmlformats.org/officeDocument/2006/relationships/image" Target="../media/image25.emf"/><Relationship Id="rId10" Type="http://schemas.openxmlformats.org/officeDocument/2006/relationships/image" Target="../media/image30.emf"/><Relationship Id="rId4" Type="http://schemas.openxmlformats.org/officeDocument/2006/relationships/image" Target="../media/image24.emf"/><Relationship Id="rId9" Type="http://schemas.openxmlformats.org/officeDocument/2006/relationships/image" Target="../media/image29.emf"/><Relationship Id="rId14" Type="http://schemas.openxmlformats.org/officeDocument/2006/relationships/image" Target="../media/image3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8.emf"/><Relationship Id="rId4" Type="http://schemas.openxmlformats.org/officeDocument/2006/relationships/image" Target="../media/image3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igure 1A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000" y="2606887"/>
            <a:ext cx="5080000" cy="1730586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xmlns="" id="{E137F2DA-6F15-B34E-88A6-1305438D664D}"/>
              </a:ext>
            </a:extLst>
          </p:cNvPr>
          <p:cNvSpPr/>
          <p:nvPr/>
        </p:nvSpPr>
        <p:spPr>
          <a:xfrm>
            <a:off x="659443" y="4937496"/>
            <a:ext cx="553911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Additional file 1: </a:t>
            </a:r>
            <a:r>
              <a:rPr lang="en-US" sz="1200" b="1" dirty="0"/>
              <a:t>Figure S1. Experimental scheme.</a:t>
            </a:r>
            <a:r>
              <a:rPr lang="en-US" sz="1200" dirty="0"/>
              <a:t> The mice were treated with 0.05% BBN in drinking water starting at 6 weeks of age and then observed at week of 8, 12, 16 and 20. The bladders were resected when the animals were sacrificed. </a:t>
            </a:r>
          </a:p>
        </p:txBody>
      </p:sp>
    </p:spTree>
    <p:extLst>
      <p:ext uri="{BB962C8B-B14F-4D97-AF65-F5344CB8AC3E}">
        <p14:creationId xmlns:p14="http://schemas.microsoft.com/office/powerpoint/2010/main" val="1669849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9586" y="417203"/>
            <a:ext cx="2032635" cy="1397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0057" y="1905510"/>
            <a:ext cx="2074545" cy="1397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5757" y="3376308"/>
            <a:ext cx="2137410" cy="13970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92267" y="4971022"/>
            <a:ext cx="2123440" cy="1397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34487" y="6495410"/>
            <a:ext cx="2172335" cy="13970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381500" y="105537"/>
            <a:ext cx="15618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table </a:t>
            </a:r>
            <a:r>
              <a:rPr lang="en-US" sz="1400" dirty="0" err="1"/>
              <a:t>transfectant</a:t>
            </a:r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1190625" y="105537"/>
            <a:ext cx="1781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ransient </a:t>
            </a:r>
            <a:r>
              <a:rPr lang="en-US" sz="1400" dirty="0" err="1"/>
              <a:t>transfectant</a:t>
            </a:r>
            <a:endParaRPr lang="en-US" sz="1400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68022" y="390718"/>
            <a:ext cx="2179320" cy="1417955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68022" y="1888430"/>
            <a:ext cx="2179320" cy="1417955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09302" y="3351548"/>
            <a:ext cx="2144395" cy="1417955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341382" y="4844390"/>
            <a:ext cx="2032635" cy="1417955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209302" y="6393543"/>
            <a:ext cx="2144395" cy="1417955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xmlns="" id="{D1E54D68-398E-B54B-8314-181FDFA19540}"/>
              </a:ext>
            </a:extLst>
          </p:cNvPr>
          <p:cNvSpPr/>
          <p:nvPr/>
        </p:nvSpPr>
        <p:spPr>
          <a:xfrm>
            <a:off x="475246" y="7881164"/>
            <a:ext cx="590750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Additional file 1: </a:t>
            </a:r>
            <a:r>
              <a:rPr lang="en-US" sz="1200" b="1" dirty="0"/>
              <a:t>Figure S2A.</a:t>
            </a:r>
            <a:r>
              <a:rPr lang="en-US" sz="1200" dirty="0"/>
              <a:t> </a:t>
            </a:r>
            <a:r>
              <a:rPr lang="en-US" sz="1200" b="1" dirty="0"/>
              <a:t>Effect of PAI-1 knockdown by transient and stable transfection on serpins in UM-UC-3cells. </a:t>
            </a:r>
            <a:r>
              <a:rPr lang="en-US" sz="1200" dirty="0"/>
              <a:t>UM-UC-3cells were transiently or stably transfected siRNA or shRNA. The levels of mRNA were analyzed by real-time RT-PCR. The copy numbers of mRNA were calculated after normalization to β-actin using absolute quantification. The data indicates copy number (target gene/β-actin). </a:t>
            </a:r>
            <a:r>
              <a:rPr lang="en-US" sz="1200" baseline="30000" dirty="0"/>
              <a:t>***</a:t>
            </a:r>
            <a:r>
              <a:rPr lang="en-US" sz="1200" dirty="0"/>
              <a:t>, </a:t>
            </a:r>
            <a:r>
              <a:rPr lang="en-US" sz="1200" i="1" dirty="0"/>
              <a:t>P</a:t>
            </a:r>
            <a:r>
              <a:rPr lang="en-US" sz="1200" dirty="0"/>
              <a:t> &lt; 0.001 </a:t>
            </a:r>
            <a:r>
              <a:rPr lang="en-US" sz="1200" i="1" dirty="0"/>
              <a:t>vs.</a:t>
            </a:r>
            <a:r>
              <a:rPr lang="en-US" sz="1200" dirty="0"/>
              <a:t> </a:t>
            </a:r>
            <a:r>
              <a:rPr lang="en-US" sz="1200" dirty="0" err="1"/>
              <a:t>siSCR</a:t>
            </a:r>
            <a:r>
              <a:rPr lang="en-US" sz="1200" dirty="0"/>
              <a:t> or </a:t>
            </a:r>
            <a:r>
              <a:rPr lang="en-US" sz="1200" dirty="0" err="1"/>
              <a:t>shSCR</a:t>
            </a:r>
            <a:r>
              <a:rPr lang="en-US" sz="1200" dirty="0"/>
              <a:t>; </a:t>
            </a:r>
            <a:r>
              <a:rPr lang="en-US" sz="1200" baseline="30000" dirty="0"/>
              <a:t>****</a:t>
            </a:r>
            <a:r>
              <a:rPr lang="en-US" sz="1200" dirty="0"/>
              <a:t>, </a:t>
            </a:r>
            <a:r>
              <a:rPr lang="en-US" sz="1200" i="1" dirty="0"/>
              <a:t>P</a:t>
            </a:r>
            <a:r>
              <a:rPr lang="en-US" sz="1200" dirty="0"/>
              <a:t> &lt; 0.0001 </a:t>
            </a:r>
            <a:r>
              <a:rPr lang="en-US" sz="1200" i="1" dirty="0"/>
              <a:t>vs.</a:t>
            </a:r>
            <a:r>
              <a:rPr lang="en-US" sz="1200" dirty="0"/>
              <a:t> </a:t>
            </a:r>
            <a:r>
              <a:rPr lang="en-US" sz="1200" dirty="0" err="1"/>
              <a:t>siSCR</a:t>
            </a:r>
            <a:r>
              <a:rPr lang="en-US" sz="1200" dirty="0"/>
              <a:t> or </a:t>
            </a:r>
            <a:r>
              <a:rPr lang="en-US" sz="1200" dirty="0" err="1"/>
              <a:t>shSCR</a:t>
            </a:r>
            <a:r>
              <a:rPr lang="en-US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7492382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376585" y="-296"/>
            <a:ext cx="922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. </a:t>
            </a:r>
            <a:r>
              <a:rPr lang="en-US" sz="1400" dirty="0" err="1"/>
              <a:t>UROtsa</a:t>
            </a:r>
            <a:endParaRPr 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4594879" y="-296"/>
            <a:ext cx="7360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B. 5637</a:t>
            </a: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4205" y="291849"/>
            <a:ext cx="2074545" cy="1417955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5145" y="1802073"/>
            <a:ext cx="2228215" cy="1417955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4205" y="3300085"/>
            <a:ext cx="2144395" cy="1417955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3735" y="4798097"/>
            <a:ext cx="2102485" cy="1417955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93265" y="6296109"/>
            <a:ext cx="2060575" cy="1417955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29780" y="291849"/>
            <a:ext cx="2032635" cy="1417955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06917" y="1802073"/>
            <a:ext cx="2053590" cy="1417955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46900" y="3300085"/>
            <a:ext cx="2200275" cy="1417955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906917" y="6296109"/>
            <a:ext cx="2053590" cy="1417955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906917" y="4798097"/>
            <a:ext cx="2053590" cy="141795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475246" y="7796758"/>
            <a:ext cx="590750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Additional file 1: </a:t>
            </a:r>
            <a:r>
              <a:rPr lang="en-US" sz="1200" b="1" dirty="0"/>
              <a:t>Figure S2B.</a:t>
            </a:r>
            <a:r>
              <a:rPr lang="en-US" sz="1200" dirty="0"/>
              <a:t> </a:t>
            </a:r>
            <a:r>
              <a:rPr lang="en-US" sz="1200" b="1" dirty="0"/>
              <a:t>Effect of PAI-1 overexpression on serpins in </a:t>
            </a:r>
            <a:r>
              <a:rPr lang="en-US" sz="1200" b="1" dirty="0" err="1"/>
              <a:t>UROtsa</a:t>
            </a:r>
            <a:r>
              <a:rPr lang="en-US" sz="1200" b="1" dirty="0"/>
              <a:t> and 5637 cells. </a:t>
            </a:r>
            <a:r>
              <a:rPr lang="en-US" sz="1200" dirty="0" err="1"/>
              <a:t>UROtsa</a:t>
            </a:r>
            <a:r>
              <a:rPr lang="en-US" sz="1200" dirty="0"/>
              <a:t> and 5637 cells were stably transfected pcDNA6.2-hPAI-1 or mock plasmid. The levels of mRNA were analyzed by real-time RT-PCR. The copy numbers of mRNA were calculated after normalization to β-actin using absolute quantification. The data indicates copy number (target gene/β-actin). </a:t>
            </a:r>
            <a:r>
              <a:rPr lang="en-US" sz="1200" baseline="30000" dirty="0"/>
              <a:t>*</a:t>
            </a:r>
            <a:r>
              <a:rPr lang="en-US" sz="1200" dirty="0"/>
              <a:t>, </a:t>
            </a:r>
            <a:r>
              <a:rPr lang="en-US" sz="1200" i="1" dirty="0"/>
              <a:t>P</a:t>
            </a:r>
            <a:r>
              <a:rPr lang="en-US" sz="1200" dirty="0"/>
              <a:t> &lt; 0.05 </a:t>
            </a:r>
            <a:r>
              <a:rPr lang="en-US" sz="1200" i="1" dirty="0"/>
              <a:t>vs.</a:t>
            </a:r>
            <a:r>
              <a:rPr lang="en-US" sz="1200" dirty="0"/>
              <a:t> Mock; </a:t>
            </a:r>
            <a:r>
              <a:rPr lang="en-US" sz="1200" baseline="30000" dirty="0"/>
              <a:t>**</a:t>
            </a:r>
            <a:r>
              <a:rPr lang="en-US" sz="1200" dirty="0"/>
              <a:t>, </a:t>
            </a:r>
            <a:r>
              <a:rPr lang="en-US" sz="1200" i="1" dirty="0"/>
              <a:t>P</a:t>
            </a:r>
            <a:r>
              <a:rPr lang="en-US" sz="1200" dirty="0"/>
              <a:t> &lt; 0.01 </a:t>
            </a:r>
            <a:r>
              <a:rPr lang="en-US" sz="1200" i="1" dirty="0"/>
              <a:t>vs.</a:t>
            </a:r>
            <a:r>
              <a:rPr lang="en-US" sz="1200" dirty="0"/>
              <a:t> Mock; </a:t>
            </a:r>
            <a:r>
              <a:rPr lang="en-US" sz="1200" baseline="30000" dirty="0"/>
              <a:t>***</a:t>
            </a:r>
            <a:r>
              <a:rPr lang="en-US" sz="1200" dirty="0"/>
              <a:t>, </a:t>
            </a:r>
            <a:r>
              <a:rPr lang="en-US" sz="1200" i="1" dirty="0"/>
              <a:t>P</a:t>
            </a:r>
            <a:r>
              <a:rPr lang="en-US" sz="1200" dirty="0"/>
              <a:t> &lt; 0.001 </a:t>
            </a:r>
            <a:r>
              <a:rPr lang="en-US" sz="1200" i="1" dirty="0"/>
              <a:t>vs.</a:t>
            </a:r>
            <a:r>
              <a:rPr lang="en-US" sz="1200" dirty="0"/>
              <a:t> Mock; </a:t>
            </a:r>
            <a:r>
              <a:rPr lang="en-US" sz="1200" baseline="30000" dirty="0"/>
              <a:t>****</a:t>
            </a:r>
            <a:r>
              <a:rPr lang="en-US" sz="1200" dirty="0"/>
              <a:t>, </a:t>
            </a:r>
            <a:r>
              <a:rPr lang="en-US" sz="1200" i="1" dirty="0"/>
              <a:t>P</a:t>
            </a:r>
            <a:r>
              <a:rPr lang="en-US" sz="1200" dirty="0"/>
              <a:t> &lt; 0.0001 </a:t>
            </a:r>
            <a:r>
              <a:rPr lang="en-US" sz="1200" i="1" dirty="0"/>
              <a:t>vs.</a:t>
            </a:r>
            <a:r>
              <a:rPr lang="en-US" sz="1200" dirty="0"/>
              <a:t> Mock.</a:t>
            </a:r>
          </a:p>
        </p:txBody>
      </p:sp>
    </p:spTree>
    <p:extLst>
      <p:ext uri="{BB962C8B-B14F-4D97-AF65-F5344CB8AC3E}">
        <p14:creationId xmlns:p14="http://schemas.microsoft.com/office/powerpoint/2010/main" val="36113808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ABB2C8F4-39FE-E241-AE66-36BA6B6849C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6670"/>
          <a:stretch/>
        </p:blipFill>
        <p:spPr>
          <a:xfrm>
            <a:off x="280713" y="390698"/>
            <a:ext cx="1898939" cy="164592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9187FF73-C674-B444-A6EE-3D0BE36A4D0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5822"/>
          <a:stretch/>
        </p:blipFill>
        <p:spPr>
          <a:xfrm>
            <a:off x="2434320" y="410628"/>
            <a:ext cx="1953457" cy="164592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A6B706DF-9A12-8B4A-AE3E-5EE35E9E720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5822"/>
          <a:stretch/>
        </p:blipFill>
        <p:spPr>
          <a:xfrm>
            <a:off x="4642445" y="410628"/>
            <a:ext cx="1953457" cy="164592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4FA2F7AB-6D9D-D147-9B04-80DC16E019B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25165"/>
          <a:stretch/>
        </p:blipFill>
        <p:spPr>
          <a:xfrm>
            <a:off x="235502" y="1983838"/>
            <a:ext cx="1970746" cy="164592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14034BFA-A781-2D41-B475-B89F14EDD7D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25165"/>
          <a:stretch/>
        </p:blipFill>
        <p:spPr>
          <a:xfrm>
            <a:off x="2443627" y="1983838"/>
            <a:ext cx="1970746" cy="164592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16EB43E3-188E-3C42-B293-7EA3D5E9763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26265"/>
          <a:stretch/>
        </p:blipFill>
        <p:spPr>
          <a:xfrm>
            <a:off x="4686481" y="1983838"/>
            <a:ext cx="1909421" cy="164592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D2BA4910-3271-6E40-A5C5-549D3877266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26548"/>
          <a:stretch/>
        </p:blipFill>
        <p:spPr>
          <a:xfrm>
            <a:off x="280713" y="3554313"/>
            <a:ext cx="1902086" cy="164592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F4E00974-2708-8A4C-B379-EC8B67562CB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r="26548"/>
          <a:stretch/>
        </p:blipFill>
        <p:spPr>
          <a:xfrm>
            <a:off x="2497626" y="3554313"/>
            <a:ext cx="1902086" cy="164592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0D566CB6-273F-544D-9126-48249B8BB2C3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r="25615"/>
          <a:stretch/>
        </p:blipFill>
        <p:spPr>
          <a:xfrm>
            <a:off x="4637008" y="3557048"/>
            <a:ext cx="1958894" cy="164592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3C674D40-29D2-4C42-B4A0-191A9DEE739D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6388"/>
          <a:stretch/>
        </p:blipFill>
        <p:spPr>
          <a:xfrm>
            <a:off x="229453" y="5198421"/>
            <a:ext cx="1938548" cy="164592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xmlns="" id="{A5566CE2-9218-B945-9A9C-09B9012E057E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r="25141"/>
          <a:stretch/>
        </p:blipFill>
        <p:spPr>
          <a:xfrm>
            <a:off x="2497626" y="5200233"/>
            <a:ext cx="1938549" cy="164592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85FFC598-745C-AE42-B407-4431F715DEDA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r="25457"/>
          <a:stretch/>
        </p:blipFill>
        <p:spPr>
          <a:xfrm>
            <a:off x="4631157" y="5198421"/>
            <a:ext cx="1964745" cy="164592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xmlns="" id="{E234E29D-462B-2F4C-838A-64BE83328E51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71018" y="6844341"/>
            <a:ext cx="2591212" cy="1645920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xmlns="" id="{86CB132B-1156-0549-806C-9C7B2C5CF2FF}"/>
              </a:ext>
            </a:extLst>
          </p:cNvPr>
          <p:cNvSpPr/>
          <p:nvPr/>
        </p:nvSpPr>
        <p:spPr>
          <a:xfrm>
            <a:off x="2903795" y="7791956"/>
            <a:ext cx="358844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Additional file 1: Figure </a:t>
            </a:r>
            <a:r>
              <a:rPr lang="en-US" sz="1200" b="1" dirty="0"/>
              <a:t>S3. Validation of expression of selected genes by qPCR.</a:t>
            </a:r>
            <a:r>
              <a:rPr lang="en-US" sz="12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8619109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1771D9AC-ED69-8F4E-9232-D924CD99AC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9259" y="1089306"/>
            <a:ext cx="2616200" cy="28448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D078CDDC-A11E-8D4F-8DC2-AAC4947FB2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75459" y="4295493"/>
            <a:ext cx="2616200" cy="28448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CD291C73-6D74-5A44-91A4-4963A7E30D6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6165"/>
          <a:stretch/>
        </p:blipFill>
        <p:spPr>
          <a:xfrm>
            <a:off x="812800" y="4295493"/>
            <a:ext cx="2616200" cy="28448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xmlns="" id="{E5233A59-7214-8E44-AC87-C647B3AED9F5}"/>
              </a:ext>
            </a:extLst>
          </p:cNvPr>
          <p:cNvSpPr/>
          <p:nvPr/>
        </p:nvSpPr>
        <p:spPr>
          <a:xfrm>
            <a:off x="859259" y="7710934"/>
            <a:ext cx="54616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/>
              <a:t>Additional file 1: Figure </a:t>
            </a:r>
            <a:r>
              <a:rPr lang="en-US" sz="1200" b="1" dirty="0"/>
              <a:t>S4. Protein expression of selected targets evaluated by IHC. </a:t>
            </a:r>
            <a:endParaRPr lang="en-US" sz="1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2866CEF8-BBA7-094B-B792-D1F100B3EAA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24854"/>
          <a:stretch/>
        </p:blipFill>
        <p:spPr>
          <a:xfrm>
            <a:off x="3429000" y="1089306"/>
            <a:ext cx="2662659" cy="2844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67580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1</TotalTime>
  <Words>275</Words>
  <Application>Microsoft Office PowerPoint</Application>
  <PresentationFormat>Letter Paper (8.5x11 in)</PresentationFormat>
  <Paragraphs>9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deki Furuya</dc:creator>
  <cp:lastModifiedBy>Shine David S.A.</cp:lastModifiedBy>
  <cp:revision>88</cp:revision>
  <cp:lastPrinted>2019-04-10T14:22:01Z</cp:lastPrinted>
  <dcterms:created xsi:type="dcterms:W3CDTF">2016-03-21T21:16:27Z</dcterms:created>
  <dcterms:modified xsi:type="dcterms:W3CDTF">2020-02-01T10:42:57Z</dcterms:modified>
</cp:coreProperties>
</file>